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99A1E-056D-4310-90D7-7FEDA28220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0F99B-DE6D-4F8C-AA3D-BC649D5017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98636-B56F-43BE-AEC8-DC4DEA0DB5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36D95-CF4C-4DFE-ADD4-2ECDF46D98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2CEAF-A8A1-4A13-A024-AD0EF7D4A1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AD2B3-9B98-4F90-B500-801F29E761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FB743-EE93-4443-AD55-0CC08C635A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C7648-D427-4149-9DA2-A32A608759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29610B-9B38-4C86-82B2-7C25C5D77F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83C928-3471-4FF8-A917-1BB880D122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FF9C4-4549-4D17-BBCB-694338011B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637A2-ADC2-4349-ABC7-42F08C051F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E15760-3669-4CF2-A5A5-00A39689F656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58800" y="2138400"/>
          <a:ext cx="7467480" cy="3235320"/>
        </p:xfrm>
        <a:graphic>
          <a:graphicData uri="http://schemas.openxmlformats.org/drawingml/2006/table">
            <a:tbl>
              <a:tblPr/>
              <a:tblGrid>
                <a:gridCol w="1208160"/>
                <a:gridCol w="1133280"/>
                <a:gridCol w="979560"/>
                <a:gridCol w="1030320"/>
                <a:gridCol w="979560"/>
                <a:gridCol w="979560"/>
                <a:gridCol w="1157040"/>
              </a:tblGrid>
              <a:tr h="307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ndi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6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mol ATP /l in the cytopla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85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82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00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D + N</a:t>
                      </a:r>
                      <a:r>
                        <a:rPr b="0" lang="de-DE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82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</a:t>
                      </a:r>
                      <a:r>
                        <a:rPr b="0" lang="de-DE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+ ligh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08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uccin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00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ndi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6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mol ATP /l in the cytopla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271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82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9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82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D + N</a:t>
                      </a:r>
                      <a:r>
                        <a:rPr b="0" lang="de-DE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00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</a:t>
                      </a:r>
                      <a:r>
                        <a:rPr b="0" lang="de-DE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+ ligh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82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uccin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4"/>
          <p:cNvSpPr/>
          <p:nvPr/>
        </p:nvSpPr>
        <p:spPr>
          <a:xfrm>
            <a:off x="539640" y="836640"/>
            <a:ext cx="7775640" cy="136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just"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TABLE S2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ATP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centration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inoroseobacter shiba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pon starvation under complex media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(ATP was measured after harvesting the cells, after anoxic incubation for 2 h, and after flushing the suspension with air in the light [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400 µE m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-2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 s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1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Calibri"/>
              </a:rPr>
              <a:t> , 2mi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] for 2 min.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05T05:20:04Z</dcterms:created>
  <dc:creator>Maya</dc:creator>
  <dc:description/>
  <dc:language>en-US</dc:language>
  <cp:lastModifiedBy>ICBM</cp:lastModifiedBy>
  <dcterms:modified xsi:type="dcterms:W3CDTF">2013-11-22T11:09:30Z</dcterms:modified>
  <cp:revision>2</cp:revision>
  <dc:subject/>
  <dc:title>PowerPoint Presentation</dc:title>
</cp:coreProperties>
</file>